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notesMasterIdLst>
    <p:notesMasterId r:id="rId4"/>
  </p:notesMasterIdLst>
  <p:sldIdLst>
    <p:sldId id="262" r:id="rId3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724"/>
    <p:restoredTop sz="96801"/>
  </p:normalViewPr>
  <p:slideViewPr>
    <p:cSldViewPr snapToGrid="0" snapToObjects="1">
      <p:cViewPr varScale="1">
        <p:scale>
          <a:sx n="88" d="100"/>
          <a:sy n="88" d="100"/>
        </p:scale>
        <p:origin x="-3234" y="-102"/>
      </p:cViewPr>
      <p:guideLst>
        <p:guide orient="horz" pos="2906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309CDF-1558-1948-A35B-90EAD1CC5E36}" type="datetimeFigureOut">
              <a:rPr lang="en-US" smtClean="0"/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7028050-2119-9D4C-B7E2-C2A26E30C5BB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7028050-2119-9D4C-B7E2-C2A26E30C5BB}" type="slidenum">
              <a:rPr lang="en-US" smtClean="0"/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4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3E836C-C2CF-414B-BCA5-FE861C8D1262}" type="datetimeFigureOut">
              <a:rPr lang="en-US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3B7E3E-DB1E-459B-8616-98F1B7372BAB}" type="slidenum">
              <a:rPr lang="en-US" altLang="en-US"/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2F4658-D6F5-40BD-9F8C-77EF04783B7F}" type="datetimeFigureOut">
              <a:rPr lang="en-US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A1B6D6-B2ED-4DBC-9085-CCC01E204C85}" type="slidenum">
              <a:rPr lang="en-US" altLang="en-US"/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8" y="488953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3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1FE5320-E11A-4FFA-A48B-C7C323C0716E}" type="datetimeFigureOut">
              <a:rPr lang="en-US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20C24C-34DC-4B6C-9639-FDE6DB9BC650}" type="slidenum">
              <a:rPr lang="en-US" altLang="en-US"/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CE3027-6451-4573-843A-D40D0C944796}" type="datetimeFigureOut">
              <a:rPr lang="en-US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A8874E-8C86-4547-92FB-664E16B96CD0}" type="slidenum">
              <a:rPr lang="en-US" altLang="en-US"/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9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5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4241B9-712B-4562-83DD-EDB39C627109}" type="datetimeFigureOut">
              <a:rPr lang="en-US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54EA89E-3B20-49A6-B3E9-157BB0E8FDD7}" type="slidenum">
              <a:rPr lang="en-US" altLang="en-US"/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0048B1-8D34-46AD-955E-2CC5960DDD8A}" type="datetimeFigureOut">
              <a:rPr lang="en-US"/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5495FC-4C92-427F-AB90-4096AC32CCE5}" type="slidenum">
              <a:rPr lang="en-US" altLang="en-US"/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3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3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3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07A347-9910-430E-963C-4DFDFC8F85AF}" type="datetimeFigureOut">
              <a:rPr lang="en-US"/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6A0F90-771E-46D9-8ECA-76B0EB490F6C}" type="slidenum">
              <a:rPr lang="en-US" altLang="en-US"/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AD9220-B3EF-4892-B3AF-211E0AEFF284}" type="datetimeFigureOut">
              <a:rPr lang="en-US"/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A559672-5932-4AA4-987B-556698E276B7}" type="slidenum">
              <a:rPr lang="en-US" altLang="en-US"/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505FCB-8FA1-4321-A833-C244F2CA8B40}" type="datetimeFigureOut">
              <a:rPr lang="en-US"/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B59822-0391-4C8C-9D43-C2870CC70B3D}" type="slidenum">
              <a:rPr lang="en-US" altLang="en-US"/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4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1" y="364074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4" y="1913473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8A4CAE-3347-4CF6-B2A0-0CB4416CAAB1}" type="datetimeFigureOut">
              <a:rPr lang="en-US"/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658EB0-57D7-442C-80D9-BD8EF75D1CC0}" type="slidenum">
              <a:rPr lang="en-US" altLang="en-US"/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8F2BDF-C206-4DDC-89C6-0FF2DCAA1A7E}" type="datetimeFigureOut">
              <a:rPr lang="en-US"/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1B9028-8BBC-4AAD-B89A-BD29D46E1157}" type="slidenum">
              <a:rPr lang="en-US" altLang="en-US"/>
            </a:fld>
            <a:endParaRPr lang="en-US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/>
          <a:lstStyle/>
          <a:p>
            <a:pPr lvl="0"/>
            <a:r>
              <a:rPr lang="en-US" altLang="en-US"/>
              <a:t>Click to edit Master title style</a:t>
            </a:r>
            <a:endParaRPr lang="en-US" altLang="en-US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/>
          <a:lstStyle/>
          <a:p>
            <a:pPr lvl="0"/>
            <a:r>
              <a:rPr lang="en-US" altLang="en-US"/>
              <a:t>Click to edit Master text styles</a:t>
            </a:r>
            <a:endParaRPr lang="en-US" altLang="en-US"/>
          </a:p>
          <a:p>
            <a:pPr lvl="1"/>
            <a:r>
              <a:rPr lang="en-US" altLang="en-US"/>
              <a:t>Second level</a:t>
            </a:r>
            <a:endParaRPr lang="en-US" altLang="en-US"/>
          </a:p>
          <a:p>
            <a:pPr lvl="2"/>
            <a:r>
              <a:rPr lang="en-US" altLang="en-US"/>
              <a:t>Third level</a:t>
            </a:r>
            <a:endParaRPr lang="en-US" altLang="en-US"/>
          </a:p>
          <a:p>
            <a:pPr lvl="3"/>
            <a:r>
              <a:rPr lang="en-US" altLang="en-US"/>
              <a:t>Fourth level</a:t>
            </a:r>
            <a:endParaRPr lang="en-US" altLang="en-US"/>
          </a:p>
          <a:p>
            <a:pPr lvl="4"/>
            <a:r>
              <a:rPr lang="en-US" altLang="en-US"/>
              <a:t>Fifth level</a:t>
            </a:r>
            <a:endParaRPr lang="en-US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6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prstClr val="black">
                    <a:tint val="75000"/>
                  </a:prst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2AE53097-FBAF-4D24-AACE-BCF21938F6C4}" type="datetimeFigureOut">
              <a:rPr lang="en-US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6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prstClr val="black">
                    <a:tint val="75000"/>
                  </a:prst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6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/>
          <a:lstStyle>
            <a:lvl1pPr algn="r" eaLnBrk="1" hangingPunct="1">
              <a:defRPr sz="120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fld id="{55F0FCB0-A81C-450A-828C-7421542915B5}" type="slidenum">
              <a:rPr lang="en-US" altLang="en-US"/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12"/>
          <p:cNvSpPr txBox="1"/>
          <p:nvPr/>
        </p:nvSpPr>
        <p:spPr>
          <a:xfrm>
            <a:off x="955675" y="5049520"/>
            <a:ext cx="5380355" cy="645160"/>
          </a:xfrm>
          <a:prstGeom prst="rect">
            <a:avLst/>
          </a:prstGeom>
          <a:solidFill>
            <a:schemeClr val="bg1"/>
          </a:solidFill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sz="1200" b="1" smtClean="0">
                <a:latin typeface="Times New Roman" panose="02020603050405020304"/>
                <a:cs typeface="Times New Roman" panose="02020603050405020304"/>
              </a:rPr>
              <a:t>Additional file 1</a:t>
            </a:r>
            <a:r>
              <a:rPr lang="en-US" sz="1200" b="1" dirty="0">
                <a:latin typeface="Times New Roman" panose="02020603050405020304"/>
                <a:cs typeface="Times New Roman" panose="02020603050405020304"/>
              </a:rPr>
              <a:t>. The weights plot of Queen in 181 counties of Sichuan Province</a:t>
            </a:r>
            <a:r>
              <a:rPr lang="en-US" sz="1200" dirty="0">
                <a:latin typeface="Times New Roman" panose="02020603050405020304"/>
                <a:cs typeface="Times New Roman" panose="02020603050405020304"/>
              </a:rPr>
              <a:t>. The common boundaries in 181 counties of Sichuan province </a:t>
            </a:r>
            <a:r>
              <a:rPr lang="en-US" sz="1200" dirty="0">
                <a:latin typeface="Times New Roman" panose="02020603050405020304"/>
                <a:cs typeface="Times New Roman" panose="02020603050405020304"/>
                <a:sym typeface="+mn-ea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can be clearly distinguished, so the queen</a:t>
            </a:r>
            <a:r>
              <a:rPr lang="en-US" sz="1200" dirty="0">
                <a:latin typeface="Times New Roman" panose="02020603050405020304"/>
                <a:cs typeface="Times New Roman" panose="02020603050405020304"/>
              </a:rPr>
              <a:t> weights were</a:t>
            </a:r>
            <a:r>
              <a:rPr lang="en-US" sz="1200" dirty="0">
                <a:latin typeface="Times New Roman" panose="02020603050405020304"/>
                <a:cs typeface="Times New Roman" panose="02020603050405020304"/>
              </a:rPr>
              <a:t> used in this manuscript.</a:t>
            </a:r>
            <a:endParaRPr lang="en-US" sz="1200" baseline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 descr="Queen权重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838200" y="349250"/>
            <a:ext cx="5181600" cy="457200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1</Words>
  <Application>WPS 演示</Application>
  <PresentationFormat>Letter Paper (8.5x11 in)</PresentationFormat>
  <Paragraphs>2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1" baseType="lpstr">
      <vt:lpstr>Arial</vt:lpstr>
      <vt:lpstr>宋体</vt:lpstr>
      <vt:lpstr>Wingdings</vt:lpstr>
      <vt:lpstr>Calibri</vt:lpstr>
      <vt:lpstr>Times New Roman</vt:lpstr>
      <vt:lpstr>Times New Roman</vt:lpstr>
      <vt:lpstr>微软雅黑</vt:lpstr>
      <vt:lpstr>Arial Unicode MS</vt:lpstr>
      <vt:lpstr>等线</vt:lpstr>
      <vt:lpstr>1_Office Them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a Rodrigues Oblessuc</dc:creator>
  <cp:lastModifiedBy>朱朱</cp:lastModifiedBy>
  <cp:revision>104</cp:revision>
  <dcterms:created xsi:type="dcterms:W3CDTF">2018-06-21T22:55:00Z</dcterms:created>
  <dcterms:modified xsi:type="dcterms:W3CDTF">2020-01-14T16:44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339</vt:lpwstr>
  </property>
</Properties>
</file>